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B6760-713B-44B8-99FA-33AAD7B65276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92DD-E806-4AD2-AE74-3A8ED01B11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3940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B6760-713B-44B8-99FA-33AAD7B65276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92DD-E806-4AD2-AE74-3A8ED01B11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2584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B6760-713B-44B8-99FA-33AAD7B65276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92DD-E806-4AD2-AE74-3A8ED01B11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3838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B6760-713B-44B8-99FA-33AAD7B65276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92DD-E806-4AD2-AE74-3A8ED01B11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2082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B6760-713B-44B8-99FA-33AAD7B65276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92DD-E806-4AD2-AE74-3A8ED01B11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70517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B6760-713B-44B8-99FA-33AAD7B65276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92DD-E806-4AD2-AE74-3A8ED01B11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412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B6760-713B-44B8-99FA-33AAD7B65276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92DD-E806-4AD2-AE74-3A8ED01B11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8920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B6760-713B-44B8-99FA-33AAD7B65276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92DD-E806-4AD2-AE74-3A8ED01B11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7388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B6760-713B-44B8-99FA-33AAD7B65276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92DD-E806-4AD2-AE74-3A8ED01B11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8117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B6760-713B-44B8-99FA-33AAD7B65276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92DD-E806-4AD2-AE74-3A8ED01B11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0608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B6760-713B-44B8-99FA-33AAD7B65276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92DD-E806-4AD2-AE74-3A8ED01B11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7329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8B6760-713B-44B8-99FA-33AAD7B65276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D92DD-E806-4AD2-AE74-3A8ED01B11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5879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368249" y="639251"/>
            <a:ext cx="704823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50000"/>
              </a:lnSpc>
            </a:pP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 Table. </a:t>
            </a:r>
            <a:endParaRPr lang="de-DE" sz="1000" b="1" dirty="0" smtClean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>
              <a:lnSpc>
                <a:spcPct val="150000"/>
              </a:lnSpc>
            </a:pP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ationship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lution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ctor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xel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nsity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lvl="0">
              <a:lnSpc>
                <a:spcPct val="150000"/>
              </a:lnSpc>
            </a:pP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ein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tracts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cending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ortic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luted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Average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xel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nsitiy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resents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ample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un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wic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t in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ame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l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Dev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Standard Deviation</a:t>
            </a:r>
            <a:endParaRPr lang="de-DE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Tabel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9941758"/>
              </p:ext>
            </p:extLst>
          </p:nvPr>
        </p:nvGraphicFramePr>
        <p:xfrm>
          <a:off x="395536" y="1628800"/>
          <a:ext cx="7188203" cy="24743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94891"/>
                <a:gridCol w="761664"/>
                <a:gridCol w="761664"/>
                <a:gridCol w="761664"/>
                <a:gridCol w="761664"/>
                <a:gridCol w="761664"/>
                <a:gridCol w="761664"/>
                <a:gridCol w="761664"/>
                <a:gridCol w="761664"/>
              </a:tblGrid>
              <a:tr h="46394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+mj-lt"/>
                        </a:rPr>
                        <a:t>Dilution factor of protein extra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pixel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</a:t>
                      </a:r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densities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Gel1a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pixel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</a:t>
                      </a:r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densities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Gel1b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smtClean="0">
                          <a:effectLst/>
                          <a:latin typeface="+mj-lt"/>
                        </a:rPr>
                        <a:t>Average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StDev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pixel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</a:t>
                      </a:r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densities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Gel2a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pixel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</a:t>
                      </a:r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densities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Gel2b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Average 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StDev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</a:tr>
              <a:tr h="154649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961748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1367075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049228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  <a:latin typeface="+mj-lt"/>
                        </a:rPr>
                        <a:t>87479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307038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284261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295649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  <a:latin typeface="+mj-lt"/>
                        </a:rPr>
                        <a:t>11388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</a:tr>
              <a:tr h="154649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490110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5001175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4951139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50035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  <a:latin typeface="+mj-lt"/>
                        </a:rPr>
                        <a:t>606258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543346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5748028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314560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</a:tr>
              <a:tr h="154649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98854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2341891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2165219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176671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  <a:latin typeface="+mj-lt"/>
                        </a:rPr>
                        <a:t>322846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294615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3087311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41157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</a:tr>
              <a:tr h="154649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22164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07859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150123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71525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  <a:latin typeface="+mj-lt"/>
                        </a:rPr>
                        <a:t>140508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98696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1196022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209060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</a:tr>
              <a:tr h="154649"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</a:tr>
              <a:tr h="154649"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</a:tr>
              <a:tr h="46394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+mj-lt"/>
                        </a:rPr>
                        <a:t>Dilution factor of protein extra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pixel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</a:t>
                      </a:r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densities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Gel3a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pixel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</a:t>
                      </a:r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densities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Gel3b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Average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StDev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pixel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</a:t>
                      </a:r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densities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Gel4a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pixel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</a:t>
                      </a:r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densities</a:t>
                      </a:r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 Gel4b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  <a:latin typeface="+mj-lt"/>
                        </a:rPr>
                        <a:t>Average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  <a:latin typeface="+mj-lt"/>
                        </a:rPr>
                        <a:t>StDev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</a:tr>
              <a:tr h="154649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2018726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2205326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2112026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93300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687492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540260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  <a:latin typeface="+mj-lt"/>
                        </a:rPr>
                        <a:t>613876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736161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</a:tr>
              <a:tr h="154649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217122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707045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962084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2550385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274000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2116347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2428175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311828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</a:tr>
              <a:tr h="154649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892088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6144631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7532758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1388127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638347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27454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1456447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181899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</a:tr>
              <a:tr h="154649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1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397292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508756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453024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55731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37074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  <a:latin typeface="+mj-lt"/>
                        </a:rPr>
                        <a:t>81718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593966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  <a:latin typeface="+mj-lt"/>
                        </a:rPr>
                        <a:t>223217.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7956471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7</Words>
  <Application>Microsoft Office PowerPoint</Application>
  <PresentationFormat>Bildschirmpräsentation (4:3)</PresentationFormat>
  <Paragraphs>9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Anke Tscheuschler</dc:creator>
  <cp:lastModifiedBy>Dr. Anke Tscheuschler</cp:lastModifiedBy>
  <cp:revision>1</cp:revision>
  <dcterms:created xsi:type="dcterms:W3CDTF">2016-09-29T14:08:12Z</dcterms:created>
  <dcterms:modified xsi:type="dcterms:W3CDTF">2016-09-29T14:09:47Z</dcterms:modified>
</cp:coreProperties>
</file>